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07" r:id="rId2"/>
  </p:sldIdLst>
  <p:sldSz cx="6858000" cy="9144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FF696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908" autoAdjust="0"/>
    <p:restoredTop sz="94660"/>
  </p:normalViewPr>
  <p:slideViewPr>
    <p:cSldViewPr>
      <p:cViewPr>
        <p:scale>
          <a:sx n="70" d="100"/>
          <a:sy n="70" d="100"/>
        </p:scale>
        <p:origin x="-1974" y="-54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40F7370-8137-48A9-9B36-93FD255E562B}" type="datetimeFigureOut">
              <a:rPr lang="ko-KR" altLang="en-US" smtClean="0"/>
              <a:t>2014-07-18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6E7F467-1671-4A64-B470-828B4B2B14C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1589745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FA8AB-BF90-470B-9813-DB5F17B4677E}" type="datetimeFigureOut">
              <a:rPr lang="ko-KR" altLang="en-US" smtClean="0"/>
              <a:t>2014-07-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421117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FA8AB-BF90-470B-9813-DB5F17B4677E}" type="datetimeFigureOut">
              <a:rPr lang="ko-KR" altLang="en-US" smtClean="0"/>
              <a:t>2014-07-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484932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FA8AB-BF90-470B-9813-DB5F17B4677E}" type="datetimeFigureOut">
              <a:rPr lang="ko-KR" altLang="en-US" smtClean="0"/>
              <a:t>2014-07-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84552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FA8AB-BF90-470B-9813-DB5F17B4677E}" type="datetimeFigureOut">
              <a:rPr lang="ko-KR" altLang="en-US" smtClean="0"/>
              <a:t>2014-07-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368592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FA8AB-BF90-470B-9813-DB5F17B4677E}" type="datetimeFigureOut">
              <a:rPr lang="ko-KR" altLang="en-US" smtClean="0"/>
              <a:t>2014-07-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707623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FA8AB-BF90-470B-9813-DB5F17B4677E}" type="datetimeFigureOut">
              <a:rPr lang="ko-KR" altLang="en-US" smtClean="0"/>
              <a:t>2014-07-1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304893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FA8AB-BF90-470B-9813-DB5F17B4677E}" type="datetimeFigureOut">
              <a:rPr lang="ko-KR" altLang="en-US" smtClean="0"/>
              <a:t>2014-07-18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971558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FA8AB-BF90-470B-9813-DB5F17B4677E}" type="datetimeFigureOut">
              <a:rPr lang="ko-KR" altLang="en-US" smtClean="0"/>
              <a:t>2014-07-18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025776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FA8AB-BF90-470B-9813-DB5F17B4677E}" type="datetimeFigureOut">
              <a:rPr lang="ko-KR" altLang="en-US" smtClean="0"/>
              <a:t>2014-07-18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542997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FA8AB-BF90-470B-9813-DB5F17B4677E}" type="datetimeFigureOut">
              <a:rPr lang="ko-KR" altLang="en-US" smtClean="0"/>
              <a:t>2014-07-1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617793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FA8AB-BF90-470B-9813-DB5F17B4677E}" type="datetimeFigureOut">
              <a:rPr lang="ko-KR" altLang="en-US" smtClean="0"/>
              <a:t>2014-07-1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511119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5FA8AB-BF90-470B-9813-DB5F17B4677E}" type="datetimeFigureOut">
              <a:rPr lang="ko-KR" altLang="en-US" smtClean="0"/>
              <a:t>2014-07-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26286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TextBox 20"/>
          <p:cNvSpPr txBox="1"/>
          <p:nvPr/>
        </p:nvSpPr>
        <p:spPr>
          <a:xfrm>
            <a:off x="5301208" y="0"/>
            <a:ext cx="15567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</a:t>
            </a:r>
            <a:r>
              <a:rPr lang="ko-KR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le 10</a:t>
            </a:r>
          </a:p>
        </p:txBody>
      </p:sp>
      <p:pic>
        <p:nvPicPr>
          <p:cNvPr id="2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3945" y="562130"/>
            <a:ext cx="4905375" cy="85820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aphicFrame>
        <p:nvGraphicFramePr>
          <p:cNvPr id="23" name="표 2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33495746"/>
              </p:ext>
            </p:extLst>
          </p:nvPr>
        </p:nvGraphicFramePr>
        <p:xfrm>
          <a:off x="5258365" y="683408"/>
          <a:ext cx="1194971" cy="8398787"/>
        </p:xfrm>
        <a:graphic>
          <a:graphicData uri="http://schemas.openxmlformats.org/drawingml/2006/table">
            <a:tbl>
              <a:tblPr/>
              <a:tblGrid>
                <a:gridCol w="1194971"/>
              </a:tblGrid>
              <a:tr h="182303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H_88708</a:t>
                      </a:r>
                    </a:p>
                  </a:txBody>
                  <a:tcPr marL="5963" marR="5963" marT="59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030A0"/>
                    </a:solidFill>
                  </a:tcPr>
                </a:tc>
              </a:tr>
              <a:tr h="182303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E1</a:t>
                      </a:r>
                    </a:p>
                  </a:txBody>
                  <a:tcPr marL="5963" marR="5963" marT="59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B050"/>
                    </a:solidFill>
                  </a:tcPr>
                </a:tc>
              </a:tr>
              <a:tr h="182303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H_139282</a:t>
                      </a:r>
                    </a:p>
                  </a:txBody>
                  <a:tcPr marL="5963" marR="5963" marT="59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030A0"/>
                    </a:solidFill>
                  </a:tcPr>
                </a:tc>
              </a:tr>
              <a:tr h="182303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G_125057</a:t>
                      </a:r>
                    </a:p>
                  </a:txBody>
                  <a:tcPr marL="5963" marR="5963" marT="59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B0F0"/>
                    </a:solidFill>
                  </a:tcPr>
                </a:tc>
              </a:tr>
              <a:tr h="182303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C1 </a:t>
                      </a:r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isoform </a:t>
                      </a:r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X7</a:t>
                      </a:r>
                    </a:p>
                  </a:txBody>
                  <a:tcPr marL="5963" marR="5963" marT="59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</a:tr>
              <a:tr h="182303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F1</a:t>
                      </a:r>
                    </a:p>
                  </a:txBody>
                  <a:tcPr marL="5963" marR="5963" marT="59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3CDDD"/>
                    </a:solidFill>
                  </a:tcPr>
                </a:tc>
              </a:tr>
              <a:tr h="182303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F2</a:t>
                      </a:r>
                    </a:p>
                  </a:txBody>
                  <a:tcPr marL="5963" marR="5963" marT="59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3CDDD"/>
                    </a:solidFill>
                  </a:tcPr>
                </a:tc>
              </a:tr>
              <a:tr h="182303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G_105304</a:t>
                      </a:r>
                    </a:p>
                  </a:txBody>
                  <a:tcPr marL="5963" marR="5963" marT="59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B0F0"/>
                    </a:solidFill>
                  </a:tcPr>
                </a:tc>
              </a:tr>
              <a:tr h="182303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A5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5963" marR="5963" marT="59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6B9B8"/>
                    </a:solidFill>
                  </a:tcPr>
                </a:tc>
              </a:tr>
              <a:tr h="182303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B6</a:t>
                      </a:r>
                    </a:p>
                  </a:txBody>
                  <a:tcPr marL="5963" marR="5963" marT="59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000"/>
                    </a:solidFill>
                  </a:tcPr>
                </a:tc>
              </a:tr>
              <a:tr h="182303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B1</a:t>
                      </a:r>
                    </a:p>
                  </a:txBody>
                  <a:tcPr marL="5963" marR="5963" marT="59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000"/>
                    </a:solidFill>
                  </a:tcPr>
                </a:tc>
              </a:tr>
              <a:tr h="182303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C1 </a:t>
                      </a:r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isoform </a:t>
                      </a:r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X5</a:t>
                      </a:r>
                    </a:p>
                  </a:txBody>
                  <a:tcPr marL="5963" marR="5963" marT="59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</a:tr>
              <a:tr h="182303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B10</a:t>
                      </a:r>
                    </a:p>
                  </a:txBody>
                  <a:tcPr marL="5963" marR="5963" marT="59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000"/>
                    </a:solidFill>
                  </a:tcPr>
                </a:tc>
              </a:tr>
              <a:tr h="182303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A1</a:t>
                      </a:r>
                    </a:p>
                  </a:txBody>
                  <a:tcPr marL="5963" marR="5963" marT="59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6B9B8"/>
                    </a:solidFill>
                  </a:tcPr>
                </a:tc>
              </a:tr>
              <a:tr h="182303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C5</a:t>
                      </a:r>
                    </a:p>
                  </a:txBody>
                  <a:tcPr marL="5963" marR="5963" marT="59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</a:tr>
              <a:tr h="182303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C1 </a:t>
                      </a:r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isoform </a:t>
                      </a:r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X9</a:t>
                      </a:r>
                    </a:p>
                  </a:txBody>
                  <a:tcPr marL="5963" marR="5963" marT="59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</a:tr>
              <a:tr h="182303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F3</a:t>
                      </a:r>
                    </a:p>
                  </a:txBody>
                  <a:tcPr marL="5963" marR="5963" marT="59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3CDDD"/>
                    </a:solidFill>
                  </a:tcPr>
                </a:tc>
              </a:tr>
              <a:tr h="182303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G5 </a:t>
                      </a:r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isoform </a:t>
                      </a:r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X1</a:t>
                      </a:r>
                    </a:p>
                  </a:txBody>
                  <a:tcPr marL="5963" marR="5963" marT="59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B0F0"/>
                    </a:solidFill>
                  </a:tcPr>
                </a:tc>
              </a:tr>
              <a:tr h="182303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B8</a:t>
                      </a:r>
                    </a:p>
                  </a:txBody>
                  <a:tcPr marL="5963" marR="5963" marT="59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000"/>
                    </a:solidFill>
                  </a:tcPr>
                </a:tc>
              </a:tr>
              <a:tr h="182303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H_103004</a:t>
                      </a:r>
                    </a:p>
                  </a:txBody>
                  <a:tcPr marL="5963" marR="5963" marT="59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030A0"/>
                    </a:solidFill>
                  </a:tcPr>
                </a:tc>
              </a:tr>
              <a:tr h="182303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H_55580</a:t>
                      </a:r>
                    </a:p>
                  </a:txBody>
                  <a:tcPr marL="5963" marR="5963" marT="59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030A0"/>
                    </a:solidFill>
                  </a:tcPr>
                </a:tc>
              </a:tr>
              <a:tr h="182303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C1 </a:t>
                      </a:r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isoform </a:t>
                      </a:r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X6</a:t>
                      </a:r>
                    </a:p>
                  </a:txBody>
                  <a:tcPr marL="5963" marR="5963" marT="59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</a:tr>
              <a:tr h="182303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G1</a:t>
                      </a:r>
                    </a:p>
                  </a:txBody>
                  <a:tcPr marL="5963" marR="5963" marT="59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B0F0"/>
                    </a:solidFill>
                  </a:tcPr>
                </a:tc>
              </a:tr>
              <a:tr h="182303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C1 </a:t>
                      </a:r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isoform </a:t>
                      </a:r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X1</a:t>
                      </a:r>
                    </a:p>
                  </a:txBody>
                  <a:tcPr marL="5963" marR="5963" marT="59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</a:tr>
              <a:tr h="182303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C1 </a:t>
                      </a:r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isoform </a:t>
                      </a:r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X8</a:t>
                      </a:r>
                    </a:p>
                  </a:txBody>
                  <a:tcPr marL="5963" marR="5963" marT="59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</a:tr>
              <a:tr h="182303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D4 </a:t>
                      </a:r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isoform </a:t>
                      </a:r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X2</a:t>
                      </a:r>
                    </a:p>
                  </a:txBody>
                  <a:tcPr marL="5963" marR="5963" marT="59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0"/>
                    </a:solidFill>
                  </a:tcPr>
                </a:tc>
              </a:tr>
              <a:tr h="182303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C1 </a:t>
                      </a:r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isoform </a:t>
                      </a:r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X2</a:t>
                      </a:r>
                    </a:p>
                  </a:txBody>
                  <a:tcPr marL="5963" marR="5963" marT="59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</a:tr>
              <a:tr h="182303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G_90506</a:t>
                      </a:r>
                    </a:p>
                  </a:txBody>
                  <a:tcPr marL="5963" marR="5963" marT="59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B0F0"/>
                    </a:solidFill>
                  </a:tcPr>
                </a:tc>
              </a:tr>
              <a:tr h="182303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C4</a:t>
                      </a:r>
                    </a:p>
                  </a:txBody>
                  <a:tcPr marL="5963" marR="5963" marT="59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</a:tr>
              <a:tr h="182303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C-like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5963" marR="5963" marT="59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</a:tr>
              <a:tr h="182303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D4 </a:t>
                      </a:r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isoform </a:t>
                      </a:r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X1</a:t>
                      </a:r>
                    </a:p>
                  </a:txBody>
                  <a:tcPr marL="5963" marR="5963" marT="59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0"/>
                    </a:solidFill>
                  </a:tcPr>
                </a:tc>
              </a:tr>
              <a:tr h="182303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C9</a:t>
                      </a:r>
                    </a:p>
                  </a:txBody>
                  <a:tcPr marL="5963" marR="5963" marT="59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</a:tr>
              <a:tr h="182303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A3 </a:t>
                      </a:r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isoform </a:t>
                      </a:r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X1</a:t>
                      </a:r>
                    </a:p>
                  </a:txBody>
                  <a:tcPr marL="5963" marR="5963" marT="59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6B9B8"/>
                    </a:solidFill>
                  </a:tcPr>
                </a:tc>
              </a:tr>
              <a:tr h="182303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G5 </a:t>
                      </a:r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isoform </a:t>
                      </a:r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X2</a:t>
                      </a:r>
                    </a:p>
                  </a:txBody>
                  <a:tcPr marL="5963" marR="5963" marT="59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B0F0"/>
                    </a:solidFill>
                  </a:tcPr>
                </a:tc>
              </a:tr>
              <a:tr h="182303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C1 </a:t>
                      </a:r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isoform </a:t>
                      </a:r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X4</a:t>
                      </a:r>
                    </a:p>
                  </a:txBody>
                  <a:tcPr marL="5963" marR="5963" marT="59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</a:tr>
              <a:tr h="182303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C2 </a:t>
                      </a:r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isoform </a:t>
                      </a:r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X1</a:t>
                      </a:r>
                    </a:p>
                  </a:txBody>
                  <a:tcPr marL="5963" marR="5963" marT="59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</a:tr>
              <a:tr h="182303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C7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5963" marR="5963" marT="59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</a:tr>
              <a:tr h="182303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A3 </a:t>
                      </a:r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isoform </a:t>
                      </a:r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X2</a:t>
                      </a:r>
                    </a:p>
                  </a:txBody>
                  <a:tcPr marL="5963" marR="5963" marT="59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6B9B8"/>
                    </a:solidFill>
                  </a:tcPr>
                </a:tc>
              </a:tr>
              <a:tr h="182303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D2</a:t>
                      </a:r>
                    </a:p>
                  </a:txBody>
                  <a:tcPr marL="5963" marR="5963" marT="59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D050"/>
                    </a:solidFill>
                  </a:tcPr>
                </a:tc>
              </a:tr>
              <a:tr h="182303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G_75152</a:t>
                      </a:r>
                    </a:p>
                  </a:txBody>
                  <a:tcPr marL="5963" marR="5963" marT="59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B0F0"/>
                    </a:solidFill>
                  </a:tcPr>
                </a:tc>
              </a:tr>
              <a:tr h="182303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A13</a:t>
                      </a:r>
                    </a:p>
                  </a:txBody>
                  <a:tcPr marL="5963" marR="5963" marT="59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6B9B8"/>
                    </a:solidFill>
                  </a:tcPr>
                </a:tc>
              </a:tr>
              <a:tr h="182303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B7</a:t>
                      </a:r>
                    </a:p>
                  </a:txBody>
                  <a:tcPr marL="5963" marR="5963" marT="59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000"/>
                    </a:solidFill>
                  </a:tcPr>
                </a:tc>
              </a:tr>
              <a:tr h="182303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C1 </a:t>
                      </a:r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isoform </a:t>
                      </a:r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X3</a:t>
                      </a:r>
                    </a:p>
                  </a:txBody>
                  <a:tcPr marL="5963" marR="5963" marT="59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</a:tr>
              <a:tr h="182303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C1 </a:t>
                      </a:r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isoform </a:t>
                      </a:r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X10</a:t>
                      </a:r>
                    </a:p>
                  </a:txBody>
                  <a:tcPr marL="5963" marR="5963" marT="59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</a:tr>
              <a:tr h="182303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C2 </a:t>
                      </a:r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isoform </a:t>
                      </a:r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X2</a:t>
                      </a:r>
                    </a:p>
                  </a:txBody>
                  <a:tcPr marL="5963" marR="5963" marT="59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</a:tr>
              <a:tr h="195152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BCH_68644</a:t>
                      </a:r>
                    </a:p>
                  </a:txBody>
                  <a:tcPr marL="5963" marR="5963" marT="59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030A0"/>
                    </a:solidFill>
                  </a:tcPr>
                </a:tc>
              </a:tr>
            </a:tbl>
          </a:graphicData>
        </a:graphic>
      </p:graphicFrame>
      <p:sp>
        <p:nvSpPr>
          <p:cNvPr id="24" name="TextBox 23"/>
          <p:cNvSpPr txBox="1"/>
          <p:nvPr/>
        </p:nvSpPr>
        <p:spPr>
          <a:xfrm>
            <a:off x="969508" y="426964"/>
            <a:ext cx="5040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altLang="ko-KR" sz="1400" b="1" dirty="0" smtClean="0">
                <a:solidFill>
                  <a:srgbClr val="000000"/>
                </a:solidFill>
                <a:latin typeface="Times New Roman" pitchFamily="18" charset="0"/>
              </a:rPr>
              <a:t>I</a:t>
            </a:r>
            <a:endParaRPr lang="en-US" altLang="ko-KR" sz="1400" dirty="0">
              <a:latin typeface="Times New Roman" pitchFamily="18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478378" y="426964"/>
            <a:ext cx="5040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altLang="ko-KR" sz="1400" b="1" dirty="0">
                <a:solidFill>
                  <a:srgbClr val="000000"/>
                </a:solidFill>
                <a:latin typeface="Times New Roman" pitchFamily="18" charset="0"/>
              </a:rPr>
              <a:t>II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999123" y="426964"/>
            <a:ext cx="5326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altLang="ko-KR" sz="1400" b="1" dirty="0">
                <a:solidFill>
                  <a:srgbClr val="000000"/>
                </a:solidFill>
                <a:latin typeface="Times New Roman" pitchFamily="18" charset="0"/>
              </a:rPr>
              <a:t>III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2567368" y="426964"/>
            <a:ext cx="5040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altLang="ko-KR" sz="1400" b="1" dirty="0">
                <a:solidFill>
                  <a:srgbClr val="000000"/>
                </a:solidFill>
                <a:latin typeface="Times New Roman" pitchFamily="18" charset="0"/>
              </a:rPr>
              <a:t>I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3099988" y="426964"/>
            <a:ext cx="5040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altLang="ko-KR" sz="1400" b="1" dirty="0">
                <a:solidFill>
                  <a:srgbClr val="000000"/>
                </a:solidFill>
                <a:latin typeface="Times New Roman" pitchFamily="18" charset="0"/>
              </a:rPr>
              <a:t>II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3608858" y="426964"/>
            <a:ext cx="5326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altLang="ko-KR" sz="1400" b="1" dirty="0">
                <a:solidFill>
                  <a:srgbClr val="000000"/>
                </a:solidFill>
                <a:latin typeface="Times New Roman" pitchFamily="18" charset="0"/>
              </a:rPr>
              <a:t>III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4165228" y="426964"/>
            <a:ext cx="5040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4697848" y="426964"/>
            <a:ext cx="5040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208603" y="-32411"/>
            <a:ext cx="346249" cy="650986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altLang="ko-KR" sz="1050" dirty="0" smtClean="0">
                <a:latin typeface="Times New Roman" pitchFamily="18" charset="0"/>
                <a:cs typeface="Times New Roman" pitchFamily="18" charset="0"/>
              </a:rPr>
              <a:t>1006.965</a:t>
            </a:r>
            <a:endParaRPr lang="ko-KR" altLang="en-US" sz="105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474383" y="-32411"/>
            <a:ext cx="346249" cy="650986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altLang="ko-KR" sz="1050" dirty="0" smtClean="0">
                <a:latin typeface="Times New Roman" pitchFamily="18" charset="0"/>
                <a:cs typeface="Times New Roman" pitchFamily="18" charset="0"/>
              </a:rPr>
              <a:t>503.4825</a:t>
            </a:r>
            <a:endParaRPr lang="ko-KR" altLang="en-US" sz="105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733637" y="86732"/>
            <a:ext cx="346249" cy="531843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altLang="ko-KR" sz="1050" dirty="0" smtClean="0">
                <a:latin typeface="Times New Roman" pitchFamily="18" charset="0"/>
                <a:cs typeface="Times New Roman" pitchFamily="18" charset="0"/>
              </a:rPr>
              <a:t>0.0</a:t>
            </a:r>
            <a:endParaRPr lang="ko-KR" altLang="en-US" sz="105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35" name="Picture 2"/>
          <p:cNvPicPr preferRelativeResize="0">
            <a:picLocks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98255"/>
          <a:stretch/>
        </p:blipFill>
        <p:spPr bwMode="auto">
          <a:xfrm>
            <a:off x="965165" y="118550"/>
            <a:ext cx="1378056" cy="785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6" name="TextBox 35"/>
          <p:cNvSpPr txBox="1"/>
          <p:nvPr/>
        </p:nvSpPr>
        <p:spPr>
          <a:xfrm>
            <a:off x="888823" y="173077"/>
            <a:ext cx="36004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0</a:t>
            </a:r>
            <a:endParaRPr lang="ko-KR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2111289" y="173077"/>
            <a:ext cx="35136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.0</a:t>
            </a:r>
            <a:endParaRPr lang="ko-KR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1499996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678</TotalTime>
  <Words>98</Words>
  <Application>Microsoft Office PowerPoint</Application>
  <PresentationFormat>화면 슬라이드 쇼(4:3)</PresentationFormat>
  <Paragraphs>60</Paragraphs>
  <Slides>1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2" baseType="lpstr">
      <vt:lpstr>Office 테마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JCB</dc:creator>
  <cp:lastModifiedBy>JSR</cp:lastModifiedBy>
  <cp:revision>165</cp:revision>
  <cp:lastPrinted>2013-12-05T12:01:32Z</cp:lastPrinted>
  <dcterms:created xsi:type="dcterms:W3CDTF">2013-01-14T11:02:46Z</dcterms:created>
  <dcterms:modified xsi:type="dcterms:W3CDTF">2014-07-18T07:28:20Z</dcterms:modified>
</cp:coreProperties>
</file>